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426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684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825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03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935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81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376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22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86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382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777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886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F975-7851-4988-A38D-447E614AFB2A}" type="datetimeFigureOut">
              <a:rPr lang="en-US" smtClean="0"/>
              <a:t>4/15/2016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41A16-7FEA-4C8C-BD09-755602D88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45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84314"/>
          <a:stretch/>
        </p:blipFill>
        <p:spPr>
          <a:xfrm>
            <a:off x="5002987" y="5113462"/>
            <a:ext cx="7153154" cy="1541797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74222"/>
          <a:stretch/>
        </p:blipFill>
        <p:spPr>
          <a:xfrm>
            <a:off x="5002987" y="3404643"/>
            <a:ext cx="7153154" cy="1475139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/>
          <a:srcRect b="81963"/>
          <a:stretch/>
        </p:blipFill>
        <p:spPr>
          <a:xfrm>
            <a:off x="5002987" y="1684824"/>
            <a:ext cx="7153154" cy="1486139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/>
          <a:srcRect b="25667"/>
          <a:stretch/>
        </p:blipFill>
        <p:spPr>
          <a:xfrm>
            <a:off x="5002987" y="141948"/>
            <a:ext cx="7153154" cy="1309196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-36397" y="79447"/>
            <a:ext cx="5047129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romoter regions of </a:t>
            </a:r>
            <a:r>
              <a:rPr lang="en-US" i="1" dirty="0" smtClean="0"/>
              <a:t>PHYHIP, POLR3D, PPP3CC </a:t>
            </a:r>
            <a:r>
              <a:rPr lang="en-US" dirty="0" smtClean="0"/>
              <a:t>and </a:t>
            </a:r>
            <a:r>
              <a:rPr lang="en-US" i="1" dirty="0" smtClean="0"/>
              <a:t>KIAA1967</a:t>
            </a:r>
            <a:r>
              <a:rPr lang="en-US" dirty="0" smtClean="0"/>
              <a:t> used in luciferase reporter vector assays.</a:t>
            </a:r>
          </a:p>
          <a:p>
            <a:r>
              <a:rPr lang="en-US" sz="1400" dirty="0" smtClean="0"/>
              <a:t>UCSC Genome Browser view of promoter regions (marked with red arrows) </a:t>
            </a:r>
            <a:r>
              <a:rPr lang="en-US" sz="1400" dirty="0"/>
              <a:t>a</a:t>
            </a:r>
            <a:r>
              <a:rPr lang="en-US" sz="1400" dirty="0" smtClean="0"/>
              <a:t>long with layered tracks of H3K4me3 chromatin modification in ENCODE Tier 1 </a:t>
            </a:r>
            <a:r>
              <a:rPr lang="en-US" sz="1400" dirty="0" smtClean="0"/>
              <a:t>and Tier 2 cell </a:t>
            </a:r>
            <a:r>
              <a:rPr lang="en-US" sz="1400" dirty="0" smtClean="0"/>
              <a:t>lines (active promoter mark, upper part of each panel) and DNaseI hypersensitivity clusters (lower part of each panel).</a:t>
            </a:r>
          </a:p>
          <a:p>
            <a:endParaRPr lang="en-US" sz="1400" dirty="0" smtClean="0"/>
          </a:p>
          <a:p>
            <a:r>
              <a:rPr lang="en-US" sz="1400" b="1" u="sng" dirty="0"/>
              <a:t>Legend for </a:t>
            </a:r>
            <a:r>
              <a:rPr lang="en-US" sz="1400" b="1" u="sng" dirty="0" smtClean="0"/>
              <a:t>H3K4me3 </a:t>
            </a:r>
            <a:r>
              <a:rPr lang="en-US" sz="1400" b="1" u="sng" dirty="0"/>
              <a:t>layered track for 7 ENCODE Tier 1 cell lines</a:t>
            </a:r>
            <a:endParaRPr lang="en-US" sz="1400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7206189" y="1048512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5529789" y="2599406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6255930" y="4311665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4806157" y="6014959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/>
          <a:srcRect l="4231" t="38775" r="83076" b="27949"/>
          <a:stretch/>
        </p:blipFill>
        <p:spPr>
          <a:xfrm>
            <a:off x="79191" y="2233883"/>
            <a:ext cx="631117" cy="930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911880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1</Words>
  <Application>Microsoft Office PowerPoint</Application>
  <PresentationFormat>Произвольный</PresentationFormat>
  <Paragraphs>4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ldar gainetdinov</dc:creator>
  <cp:lastModifiedBy>S</cp:lastModifiedBy>
  <cp:revision>2</cp:revision>
  <dcterms:created xsi:type="dcterms:W3CDTF">2016-04-15T08:10:47Z</dcterms:created>
  <dcterms:modified xsi:type="dcterms:W3CDTF">2016-04-15T10:19:49Z</dcterms:modified>
</cp:coreProperties>
</file>